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1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78" d="100"/>
          <a:sy n="78" d="100"/>
        </p:scale>
        <p:origin x="216" y="56"/>
      </p:cViewPr>
      <p:guideLst>
        <p:guide orient="horz" pos="2160"/>
        <p:guide pos="381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271724D-6FBA-4868-B20A-D0E0BB2192A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AF6A0ED6-EE3A-4191-9854-580D5498C75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672BF16-94E9-4C79-984E-4E84675E42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DAE9D-5DD9-417A-BAFD-3C2250241E5E}" type="datetimeFigureOut">
              <a:rPr kumimoji="1" lang="ja-JP" altLang="en-US" smtClean="0"/>
              <a:t>2019/10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353AD8D-8EEE-42D8-B765-5C2B169F09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F09EF52-2409-411C-9381-33826C4E17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76EF5-2573-4552-A724-6B8B485BAF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7469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BF4F084-0015-4088-AACE-20CE29956B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F535E13-829B-4DB7-9964-487EA5E410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16B50FE-73C4-4A05-B1EB-087B4F4598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DAE9D-5DD9-417A-BAFD-3C2250241E5E}" type="datetimeFigureOut">
              <a:rPr kumimoji="1" lang="ja-JP" altLang="en-US" smtClean="0"/>
              <a:t>2019/10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7AD40E4-CEFF-4FFF-94E9-2118394011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0B8EA41-55BC-42A1-9A5D-7BFFF913C3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76EF5-2573-4552-A724-6B8B485BAF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59577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D42645C-5A75-4C38-92FD-BAF3F2625DC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2CBD505-29D1-4908-865B-E89B354CDEA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67CFA7E-BD2D-4AD1-A9C9-D68581A72B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DAE9D-5DD9-417A-BAFD-3C2250241E5E}" type="datetimeFigureOut">
              <a:rPr kumimoji="1" lang="ja-JP" altLang="en-US" smtClean="0"/>
              <a:t>2019/10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9934F06-0A8D-48F9-AED6-6E375CC21C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B8AE3A3-8B1E-40BD-8350-8CF5E1557B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76EF5-2573-4552-A724-6B8B485BAF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05911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9642B7C-4EF8-4547-BBF9-7AC2B56E7D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2D1B45D-FDD0-4C13-92DD-FF01FF89879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79B23B8-92E3-4EC1-9099-C76A863436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DAE9D-5DD9-417A-BAFD-3C2250241E5E}" type="datetimeFigureOut">
              <a:rPr kumimoji="1" lang="ja-JP" altLang="en-US" smtClean="0"/>
              <a:t>2019/10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38E2E42-7A80-48B4-B5C1-68409A81D9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2B1D631-83F6-4A0F-AEB7-15004558B1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76EF5-2573-4552-A724-6B8B485BAF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26579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76E0150-5C93-4372-802D-F48DC0B3A8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381DC52-7B96-4037-9810-565ED4F177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55193BB-18B1-42A0-BCF4-6EB46DD129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DAE9D-5DD9-417A-BAFD-3C2250241E5E}" type="datetimeFigureOut">
              <a:rPr kumimoji="1" lang="ja-JP" altLang="en-US" smtClean="0"/>
              <a:t>2019/10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9EC9DE6-10EA-4DCF-A2A7-F7E05F9B3B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8C51DBD-E15B-4C4C-9BEB-7F325F2F51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76EF5-2573-4552-A724-6B8B485BAF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81779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53779C9-CD5D-40BE-9384-60F38853FB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ABFEC2A-B79C-488C-AB65-247DDEC1A6C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4A8821C-DC22-4BFB-BE56-90F54D40C6E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AEAF6AB-AECE-4073-866D-5977074435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DAE9D-5DD9-417A-BAFD-3C2250241E5E}" type="datetimeFigureOut">
              <a:rPr kumimoji="1" lang="ja-JP" altLang="en-US" smtClean="0"/>
              <a:t>2019/10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0493027-AD04-4995-A851-983BB037E0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6C68B7C-4ABB-49B3-9E74-777EF9178B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76EF5-2573-4552-A724-6B8B485BAF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35297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42ABB53-774A-4CE6-AA77-188AAC3C43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4EABFC4-F0B9-4EAB-9160-D031FFE8D8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DE8A62E-65A6-4624-9DF7-CAD815F7F3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D3502569-47B7-4685-9FBD-5131EEDABE2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0F101D1D-2882-45EE-B325-079D4771E7D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BED17B8E-EC0F-486F-A18C-8E7E70AFE4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DAE9D-5DD9-417A-BAFD-3C2250241E5E}" type="datetimeFigureOut">
              <a:rPr kumimoji="1" lang="ja-JP" altLang="en-US" smtClean="0"/>
              <a:t>2019/10/2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3ED3E44D-2695-433D-88CF-474ACB750F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C8BCC92B-E348-4987-8BE7-B4D8A6549D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76EF5-2573-4552-A724-6B8B485BAF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54024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734C4E8-CAE3-402F-B09C-02A33669A5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65DA6997-BB4C-4CCD-9611-CC1DA70824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DAE9D-5DD9-417A-BAFD-3C2250241E5E}" type="datetimeFigureOut">
              <a:rPr kumimoji="1" lang="ja-JP" altLang="en-US" smtClean="0"/>
              <a:t>2019/10/2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08C52CA-9697-4A63-8DCE-FCF3315974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5E6A643-ED42-4A95-BE30-2715947681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76EF5-2573-4552-A724-6B8B485BAF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73724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C76A45C0-26BD-4B55-BE41-CFE171503F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DAE9D-5DD9-417A-BAFD-3C2250241E5E}" type="datetimeFigureOut">
              <a:rPr kumimoji="1" lang="ja-JP" altLang="en-US" smtClean="0"/>
              <a:t>2019/10/2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E748362F-DD90-4663-A91F-6C86F4A453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8B5620A-A484-413C-B8C3-634E7B66C6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76EF5-2573-4552-A724-6B8B485BAF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8028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63CEEF7-36C3-4DBE-A3DD-8FD527C122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A0994C5-02D4-4AB8-893B-8C7FC53BE5E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53F4D88-2DE6-4852-876E-DFB70A4522D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318F94A-A266-4FFB-959E-D7213A8BF4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DAE9D-5DD9-417A-BAFD-3C2250241E5E}" type="datetimeFigureOut">
              <a:rPr kumimoji="1" lang="ja-JP" altLang="en-US" smtClean="0"/>
              <a:t>2019/10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B02E0BC-E581-400C-B87C-3F8A351D92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D58B033-746E-4C7C-B2F0-B9798052C9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76EF5-2573-4552-A724-6B8B485BAF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77899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74CDA8A-9189-4292-B16B-282AC934B4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BB7F07B-A888-4AE1-9067-D6DBE3C77B7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D7B0364-F300-41B7-AB3A-8BD523D988A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5CF7E33-AE7E-49F7-812A-C3BE21A53D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DAE9D-5DD9-417A-BAFD-3C2250241E5E}" type="datetimeFigureOut">
              <a:rPr kumimoji="1" lang="ja-JP" altLang="en-US" smtClean="0"/>
              <a:t>2019/10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26E907B-F6F0-4283-8F8E-ED205E97A7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F649B5D-74F9-480A-99BF-DF00B80173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76EF5-2573-4552-A724-6B8B485BAF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38723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5ED8CA33-E81E-4164-AE3C-55674A0576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8D630E1-633E-46B5-852A-8FADC43134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B1D8D5C-E21E-4609-8D1C-47A54ADF31A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DDAE9D-5DD9-417A-BAFD-3C2250241E5E}" type="datetimeFigureOut">
              <a:rPr kumimoji="1" lang="ja-JP" altLang="en-US" smtClean="0"/>
              <a:t>2019/10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BA1A700-7E1F-4809-A93D-1DE23E71C95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F7D6837-394D-45B3-80E1-C172CB799F7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576EF5-2573-4552-A724-6B8B485BAF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45208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図 14">
            <a:extLst>
              <a:ext uri="{FF2B5EF4-FFF2-40B4-BE49-F238E27FC236}">
                <a16:creationId xmlns:a16="http://schemas.microsoft.com/office/drawing/2014/main" id="{E3D97741-C5F9-4AAE-83D5-23FC6B9D16B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610" r="51611" b="22968"/>
          <a:stretch/>
        </p:blipFill>
        <p:spPr>
          <a:xfrm>
            <a:off x="7007523" y="1345560"/>
            <a:ext cx="4600108" cy="3046316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CDC940C6-D15C-4925-8C28-51B5500B090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104" r="50678" b="22512"/>
          <a:stretch/>
        </p:blipFill>
        <p:spPr>
          <a:xfrm>
            <a:off x="979264" y="1428897"/>
            <a:ext cx="4673840" cy="3014444"/>
          </a:xfrm>
          <a:prstGeom prst="rect">
            <a:avLst/>
          </a:prstGeom>
        </p:spPr>
      </p:pic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AB883C48-BBD3-4A99-90D6-A6C5AE9A744A}"/>
              </a:ext>
            </a:extLst>
          </p:cNvPr>
          <p:cNvSpPr/>
          <p:nvPr/>
        </p:nvSpPr>
        <p:spPr>
          <a:xfrm>
            <a:off x="3616052" y="1868446"/>
            <a:ext cx="1008609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50" dirty="0">
                <a:solidFill>
                  <a:schemeClr val="accent5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rmal group</a:t>
            </a:r>
            <a:endParaRPr lang="ja-JP" altLang="en-US" sz="1050" dirty="0">
              <a:solidFill>
                <a:schemeClr val="accent5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2CEEC590-275F-4D2D-BD29-85710E7B6653}"/>
              </a:ext>
            </a:extLst>
          </p:cNvPr>
          <p:cNvSpPr/>
          <p:nvPr/>
        </p:nvSpPr>
        <p:spPr>
          <a:xfrm>
            <a:off x="10199981" y="1606502"/>
            <a:ext cx="1008609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50" dirty="0">
                <a:solidFill>
                  <a:schemeClr val="accent5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rmal group</a:t>
            </a:r>
            <a:endParaRPr lang="ja-JP" altLang="en-US" sz="1050" dirty="0">
              <a:solidFill>
                <a:schemeClr val="accent5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42AA2DFE-46B3-4B2B-BE6F-50D5BCD01957}"/>
              </a:ext>
            </a:extLst>
          </p:cNvPr>
          <p:cNvSpPr/>
          <p:nvPr/>
        </p:nvSpPr>
        <p:spPr>
          <a:xfrm>
            <a:off x="3408342" y="2269395"/>
            <a:ext cx="1260281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50" dirty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rmalized group</a:t>
            </a:r>
            <a:endParaRPr lang="ja-JP" altLang="en-US" sz="1050" dirty="0">
              <a:solidFill>
                <a:schemeClr val="accent6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918E5189-8CA7-4C33-AA19-FEFFF9F1FB29}"/>
              </a:ext>
            </a:extLst>
          </p:cNvPr>
          <p:cNvSpPr/>
          <p:nvPr/>
        </p:nvSpPr>
        <p:spPr>
          <a:xfrm>
            <a:off x="9966737" y="1901704"/>
            <a:ext cx="1260281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50" dirty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rmalized group</a:t>
            </a:r>
            <a:endParaRPr lang="ja-JP" altLang="en-US" sz="1050" dirty="0">
              <a:solidFill>
                <a:schemeClr val="accent6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C6AEE169-A10C-4E37-8DC4-F3D1F63DF479}"/>
              </a:ext>
            </a:extLst>
          </p:cNvPr>
          <p:cNvSpPr/>
          <p:nvPr/>
        </p:nvSpPr>
        <p:spPr>
          <a:xfrm>
            <a:off x="3377744" y="2773720"/>
            <a:ext cx="1107996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5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levated group</a:t>
            </a:r>
            <a:endParaRPr lang="ja-JP" altLang="en-US" sz="105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417F8CAA-604B-4A03-82EC-F7FEF6B62D0C}"/>
              </a:ext>
            </a:extLst>
          </p:cNvPr>
          <p:cNvSpPr/>
          <p:nvPr/>
        </p:nvSpPr>
        <p:spPr>
          <a:xfrm>
            <a:off x="10177892" y="2603829"/>
            <a:ext cx="1107996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5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levated group</a:t>
            </a:r>
            <a:endParaRPr lang="ja-JP" altLang="en-US" sz="105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5F0BD6F7-9BF6-48E9-812F-C9C4022783F5}"/>
              </a:ext>
            </a:extLst>
          </p:cNvPr>
          <p:cNvSpPr txBox="1"/>
          <p:nvPr/>
        </p:nvSpPr>
        <p:spPr>
          <a:xfrm>
            <a:off x="4753745" y="3023115"/>
            <a:ext cx="19608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64EA2C68-C6E7-4656-A716-33BF07129BD4}"/>
              </a:ext>
            </a:extLst>
          </p:cNvPr>
          <p:cNvSpPr/>
          <p:nvPr/>
        </p:nvSpPr>
        <p:spPr>
          <a:xfrm>
            <a:off x="10776398" y="2934569"/>
            <a:ext cx="766557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7C753DA4-B8D2-4965-9E30-3F5AC0EE4685}"/>
              </a:ext>
            </a:extLst>
          </p:cNvPr>
          <p:cNvSpPr/>
          <p:nvPr/>
        </p:nvSpPr>
        <p:spPr>
          <a:xfrm>
            <a:off x="2426565" y="955418"/>
            <a:ext cx="276229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ecurrence-free survival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3839C6A8-A4AE-4AFF-8B56-3B63C309C0BA}"/>
              </a:ext>
            </a:extLst>
          </p:cNvPr>
          <p:cNvSpPr/>
          <p:nvPr/>
        </p:nvSpPr>
        <p:spPr>
          <a:xfrm>
            <a:off x="8588392" y="926671"/>
            <a:ext cx="180209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Overall survival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F725951-7EB2-4B81-99AE-9ADE2A487EBA}"/>
              </a:ext>
            </a:extLst>
          </p:cNvPr>
          <p:cNvSpPr txBox="1"/>
          <p:nvPr/>
        </p:nvSpPr>
        <p:spPr>
          <a:xfrm>
            <a:off x="1779335" y="4178193"/>
            <a:ext cx="400898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        2        3       4        5        6       7        8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40A0EF57-E17B-4D94-922E-9CA71A6D568E}"/>
              </a:ext>
            </a:extLst>
          </p:cNvPr>
          <p:cNvSpPr txBox="1"/>
          <p:nvPr/>
        </p:nvSpPr>
        <p:spPr>
          <a:xfrm rot="16200000">
            <a:off x="-394389" y="2713052"/>
            <a:ext cx="2473282" cy="33537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Recurrence-free survival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D64782CC-FF47-403C-8DAD-EBD3FBF34165}"/>
              </a:ext>
            </a:extLst>
          </p:cNvPr>
          <p:cNvSpPr/>
          <p:nvPr/>
        </p:nvSpPr>
        <p:spPr>
          <a:xfrm rot="16200000">
            <a:off x="6091057" y="2769307"/>
            <a:ext cx="1585690" cy="338554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Overall survival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7F39267A-FF12-41A0-9174-E4CDF0E9CBC8}"/>
              </a:ext>
            </a:extLst>
          </p:cNvPr>
          <p:cNvSpPr txBox="1"/>
          <p:nvPr/>
        </p:nvSpPr>
        <p:spPr>
          <a:xfrm>
            <a:off x="2701250" y="4435282"/>
            <a:ext cx="2509520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y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ears after surgery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図 25">
            <a:extLst>
              <a:ext uri="{FF2B5EF4-FFF2-40B4-BE49-F238E27FC236}">
                <a16:creationId xmlns:a16="http://schemas.microsoft.com/office/drawing/2014/main" id="{E5C9A4DE-8AF8-413C-816F-E7EE842B0A5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721049" y="4399553"/>
            <a:ext cx="2542252" cy="432854"/>
          </a:xfrm>
          <a:prstGeom prst="rect">
            <a:avLst/>
          </a:prstGeom>
        </p:spPr>
      </p:pic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93B1770E-1579-4AE6-9FCF-423BFAF2829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33959976"/>
              </p:ext>
            </p:extLst>
          </p:nvPr>
        </p:nvGraphicFramePr>
        <p:xfrm>
          <a:off x="-96378" y="4442654"/>
          <a:ext cx="5501135" cy="914400"/>
        </p:xfrm>
        <a:graphic>
          <a:graphicData uri="http://schemas.openxmlformats.org/drawingml/2006/table">
            <a:tbl>
              <a:tblPr/>
              <a:tblGrid>
                <a:gridCol w="1477732">
                  <a:extLst>
                    <a:ext uri="{9D8B030D-6E8A-4147-A177-3AD203B41FA5}">
                      <a16:colId xmlns:a16="http://schemas.microsoft.com/office/drawing/2014/main" val="869480250"/>
                    </a:ext>
                  </a:extLst>
                </a:gridCol>
                <a:gridCol w="251959">
                  <a:extLst>
                    <a:ext uri="{9D8B030D-6E8A-4147-A177-3AD203B41FA5}">
                      <a16:colId xmlns:a16="http://schemas.microsoft.com/office/drawing/2014/main" val="780415635"/>
                    </a:ext>
                  </a:extLst>
                </a:gridCol>
                <a:gridCol w="423252">
                  <a:extLst>
                    <a:ext uri="{9D8B030D-6E8A-4147-A177-3AD203B41FA5}">
                      <a16:colId xmlns:a16="http://schemas.microsoft.com/office/drawing/2014/main" val="772102695"/>
                    </a:ext>
                  </a:extLst>
                </a:gridCol>
                <a:gridCol w="490692">
                  <a:extLst>
                    <a:ext uri="{9D8B030D-6E8A-4147-A177-3AD203B41FA5}">
                      <a16:colId xmlns:a16="http://schemas.microsoft.com/office/drawing/2014/main" val="2132968379"/>
                    </a:ext>
                  </a:extLst>
                </a:gridCol>
                <a:gridCol w="489857">
                  <a:extLst>
                    <a:ext uri="{9D8B030D-6E8A-4147-A177-3AD203B41FA5}">
                      <a16:colId xmlns:a16="http://schemas.microsoft.com/office/drawing/2014/main" val="2734053899"/>
                    </a:ext>
                  </a:extLst>
                </a:gridCol>
                <a:gridCol w="489857">
                  <a:extLst>
                    <a:ext uri="{9D8B030D-6E8A-4147-A177-3AD203B41FA5}">
                      <a16:colId xmlns:a16="http://schemas.microsoft.com/office/drawing/2014/main" val="1746107075"/>
                    </a:ext>
                  </a:extLst>
                </a:gridCol>
                <a:gridCol w="457200">
                  <a:extLst>
                    <a:ext uri="{9D8B030D-6E8A-4147-A177-3AD203B41FA5}">
                      <a16:colId xmlns:a16="http://schemas.microsoft.com/office/drawing/2014/main" val="2712783719"/>
                    </a:ext>
                  </a:extLst>
                </a:gridCol>
                <a:gridCol w="506186">
                  <a:extLst>
                    <a:ext uri="{9D8B030D-6E8A-4147-A177-3AD203B41FA5}">
                      <a16:colId xmlns:a16="http://schemas.microsoft.com/office/drawing/2014/main" val="3101912870"/>
                    </a:ext>
                  </a:extLst>
                </a:gridCol>
                <a:gridCol w="424543">
                  <a:extLst>
                    <a:ext uri="{9D8B030D-6E8A-4147-A177-3AD203B41FA5}">
                      <a16:colId xmlns:a16="http://schemas.microsoft.com/office/drawing/2014/main" val="3481771956"/>
                    </a:ext>
                  </a:extLst>
                </a:gridCol>
                <a:gridCol w="489857">
                  <a:extLst>
                    <a:ext uri="{9D8B030D-6E8A-4147-A177-3AD203B41FA5}">
                      <a16:colId xmlns:a16="http://schemas.microsoft.com/office/drawing/2014/main" val="1578207752"/>
                    </a:ext>
                  </a:extLst>
                </a:gridCol>
              </a:tblGrid>
              <a:tr h="228600"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No. at risk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615515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normal group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33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23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119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2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90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79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0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5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5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595624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normalized group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4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2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9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7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5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10149612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elevated group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532226"/>
                  </a:ext>
                </a:extLst>
              </a:tr>
            </a:tbl>
          </a:graphicData>
        </a:graphic>
      </p:graphicFrame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B2302148-1CA1-437E-BA50-9B535C0F27E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45463803"/>
              </p:ext>
            </p:extLst>
          </p:nvPr>
        </p:nvGraphicFramePr>
        <p:xfrm>
          <a:off x="5893552" y="4441433"/>
          <a:ext cx="5593598" cy="914400"/>
        </p:xfrm>
        <a:graphic>
          <a:graphicData uri="http://schemas.openxmlformats.org/drawingml/2006/table">
            <a:tbl>
              <a:tblPr/>
              <a:tblGrid>
                <a:gridCol w="1376120">
                  <a:extLst>
                    <a:ext uri="{9D8B030D-6E8A-4147-A177-3AD203B41FA5}">
                      <a16:colId xmlns:a16="http://schemas.microsoft.com/office/drawing/2014/main" val="1174219194"/>
                    </a:ext>
                  </a:extLst>
                </a:gridCol>
                <a:gridCol w="299531">
                  <a:extLst>
                    <a:ext uri="{9D8B030D-6E8A-4147-A177-3AD203B41FA5}">
                      <a16:colId xmlns:a16="http://schemas.microsoft.com/office/drawing/2014/main" val="1373669185"/>
                    </a:ext>
                  </a:extLst>
                </a:gridCol>
                <a:gridCol w="529768">
                  <a:extLst>
                    <a:ext uri="{9D8B030D-6E8A-4147-A177-3AD203B41FA5}">
                      <a16:colId xmlns:a16="http://schemas.microsoft.com/office/drawing/2014/main" val="415190481"/>
                    </a:ext>
                  </a:extLst>
                </a:gridCol>
                <a:gridCol w="506186">
                  <a:extLst>
                    <a:ext uri="{9D8B030D-6E8A-4147-A177-3AD203B41FA5}">
                      <a16:colId xmlns:a16="http://schemas.microsoft.com/office/drawing/2014/main" val="2376685837"/>
                    </a:ext>
                  </a:extLst>
                </a:gridCol>
                <a:gridCol w="538843">
                  <a:extLst>
                    <a:ext uri="{9D8B030D-6E8A-4147-A177-3AD203B41FA5}">
                      <a16:colId xmlns:a16="http://schemas.microsoft.com/office/drawing/2014/main" val="3860343853"/>
                    </a:ext>
                  </a:extLst>
                </a:gridCol>
                <a:gridCol w="457200">
                  <a:extLst>
                    <a:ext uri="{9D8B030D-6E8A-4147-A177-3AD203B41FA5}">
                      <a16:colId xmlns:a16="http://schemas.microsoft.com/office/drawing/2014/main" val="323594654"/>
                    </a:ext>
                  </a:extLst>
                </a:gridCol>
                <a:gridCol w="449036">
                  <a:extLst>
                    <a:ext uri="{9D8B030D-6E8A-4147-A177-3AD203B41FA5}">
                      <a16:colId xmlns:a16="http://schemas.microsoft.com/office/drawing/2014/main" val="2458462917"/>
                    </a:ext>
                  </a:extLst>
                </a:gridCol>
                <a:gridCol w="473528">
                  <a:extLst>
                    <a:ext uri="{9D8B030D-6E8A-4147-A177-3AD203B41FA5}">
                      <a16:colId xmlns:a16="http://schemas.microsoft.com/office/drawing/2014/main" val="3609667841"/>
                    </a:ext>
                  </a:extLst>
                </a:gridCol>
                <a:gridCol w="465365">
                  <a:extLst>
                    <a:ext uri="{9D8B030D-6E8A-4147-A177-3AD203B41FA5}">
                      <a16:colId xmlns:a16="http://schemas.microsoft.com/office/drawing/2014/main" val="3205856914"/>
                    </a:ext>
                  </a:extLst>
                </a:gridCol>
                <a:gridCol w="498021">
                  <a:extLst>
                    <a:ext uri="{9D8B030D-6E8A-4147-A177-3AD203B41FA5}">
                      <a16:colId xmlns:a16="http://schemas.microsoft.com/office/drawing/2014/main" val="266935765"/>
                    </a:ext>
                  </a:extLst>
                </a:gridCol>
              </a:tblGrid>
              <a:tr h="228600"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No. at risk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051613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normal group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33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30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24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16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5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91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9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53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1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2087082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normalized group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4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39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3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2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9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7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59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716557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elevated group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136271"/>
                  </a:ext>
                </a:extLst>
              </a:tr>
            </a:tbl>
          </a:graphicData>
        </a:graphic>
      </p:graphicFrame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4D37EDDE-B61C-43C5-91DB-FA9676BE32AC}"/>
              </a:ext>
            </a:extLst>
          </p:cNvPr>
          <p:cNvSpPr txBox="1"/>
          <p:nvPr/>
        </p:nvSpPr>
        <p:spPr>
          <a:xfrm>
            <a:off x="5465512" y="349561"/>
            <a:ext cx="12609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utoff 10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69C5E2AD-B2C2-44A0-A0B2-4067F6B007BF}"/>
              </a:ext>
            </a:extLst>
          </p:cNvPr>
          <p:cNvSpPr txBox="1"/>
          <p:nvPr/>
        </p:nvSpPr>
        <p:spPr>
          <a:xfrm>
            <a:off x="7793692" y="4153156"/>
            <a:ext cx="400898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        2        3       4        5        6       7        8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9A96B7B2-41DA-4489-96AC-D84633E82F86}"/>
              </a:ext>
            </a:extLst>
          </p:cNvPr>
          <p:cNvSpPr txBox="1"/>
          <p:nvPr/>
        </p:nvSpPr>
        <p:spPr>
          <a:xfrm>
            <a:off x="448516" y="287677"/>
            <a:ext cx="33881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174343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65</TotalTime>
  <Words>126</Words>
  <Application>Microsoft Office PowerPoint</Application>
  <PresentationFormat>ワイド画面</PresentationFormat>
  <Paragraphs>7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EA追加解析</dc:title>
  <dc:creator>中村 友哉</dc:creator>
  <cp:lastModifiedBy>中村　友哉</cp:lastModifiedBy>
  <cp:revision>33</cp:revision>
  <dcterms:created xsi:type="dcterms:W3CDTF">2019-06-01T06:54:52Z</dcterms:created>
  <dcterms:modified xsi:type="dcterms:W3CDTF">2019-10-23T09:52:36Z</dcterms:modified>
</cp:coreProperties>
</file>